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14" r:id="rId2"/>
    <p:sldId id="316" r:id="rId3"/>
    <p:sldId id="317" r:id="rId4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11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3AE60-F099-4DC7-946C-DDD229AB157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2C3D5-2E60-440C-8B25-F9A4BEDE693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013472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3AE60-F099-4DC7-946C-DDD229AB157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2C3D5-2E60-440C-8B25-F9A4BEDE693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01853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3AE60-F099-4DC7-946C-DDD229AB157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2C3D5-2E60-440C-8B25-F9A4BEDE693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509397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3AE60-F099-4DC7-946C-DDD229AB157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2C3D5-2E60-440C-8B25-F9A4BEDE693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453031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3AE60-F099-4DC7-946C-DDD229AB157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2C3D5-2E60-440C-8B25-F9A4BEDE693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786784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3AE60-F099-4DC7-946C-DDD229AB157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2C3D5-2E60-440C-8B25-F9A4BEDE693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62572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3AE60-F099-4DC7-946C-DDD229AB157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2C3D5-2E60-440C-8B25-F9A4BEDE693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01937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3AE60-F099-4DC7-946C-DDD229AB157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2C3D5-2E60-440C-8B25-F9A4BEDE693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60384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3AE60-F099-4DC7-946C-DDD229AB157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2C3D5-2E60-440C-8B25-F9A4BEDE693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15335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3AE60-F099-4DC7-946C-DDD229AB157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2C3D5-2E60-440C-8B25-F9A4BEDE693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97455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3AE60-F099-4DC7-946C-DDD229AB157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52C3D5-2E60-440C-8B25-F9A4BEDE693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510090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B3AE60-F099-4DC7-946C-DDD229AB157A}" type="datetimeFigureOut">
              <a:rPr lang="en-IN" smtClean="0"/>
              <a:t>04-02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52C3D5-2E60-440C-8B25-F9A4BEDE693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05930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3BE6204-79A2-4DBC-B041-2D26BA360FD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668"/>
          <a:stretch/>
        </p:blipFill>
        <p:spPr>
          <a:xfrm>
            <a:off x="586561" y="1334517"/>
            <a:ext cx="4366439" cy="457661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99A15A6-E959-4988-81B2-A048B44A9CC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4514" y="1142951"/>
            <a:ext cx="4343493" cy="457209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151A2E4-74ED-40BA-A6FD-0F759736BBCD}"/>
              </a:ext>
            </a:extLst>
          </p:cNvPr>
          <p:cNvSpPr txBox="1"/>
          <p:nvPr/>
        </p:nvSpPr>
        <p:spPr>
          <a:xfrm>
            <a:off x="6896571" y="5914981"/>
            <a:ext cx="3125107" cy="3174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63" dirty="0">
                <a:solidFill>
                  <a:srgbClr val="202124"/>
                </a:solidFill>
                <a:latin typeface="arial" panose="020B0604020202020204" pitchFamily="34" charset="0"/>
              </a:rPr>
              <a:t>M (log ratio) and A (mean average)</a:t>
            </a:r>
            <a:endParaRPr lang="en-IN" sz="1463" dirty="0"/>
          </a:p>
        </p:txBody>
      </p:sp>
    </p:spTree>
    <p:extLst>
      <p:ext uri="{BB962C8B-B14F-4D97-AF65-F5344CB8AC3E}">
        <p14:creationId xmlns:p14="http://schemas.microsoft.com/office/powerpoint/2010/main" val="4644720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EC0DA96-FC7F-4603-8810-E254006738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2890" y="1142951"/>
            <a:ext cx="4343493" cy="457209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9D74083-10CB-4767-8843-184C2740446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235" y="642938"/>
            <a:ext cx="5014913" cy="5572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33829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A6EA2F1-2359-4065-8D06-FB571BEB98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721" y="392681"/>
            <a:ext cx="5014913" cy="557212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E4FACF2-7208-41C5-B033-70D568C812C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5634" y="806067"/>
            <a:ext cx="4343493" cy="457209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A1BC578-BD90-4FFB-85FC-F8874458E29E}"/>
              </a:ext>
            </a:extLst>
          </p:cNvPr>
          <p:cNvSpPr txBox="1"/>
          <p:nvPr/>
        </p:nvSpPr>
        <p:spPr>
          <a:xfrm>
            <a:off x="173255" y="5778109"/>
            <a:ext cx="9490509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. 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at map and MA-plots. Heat map and MA-plots were generated between control and infected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amples from 12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pi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36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pi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48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pi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Yellow - low-level expression; Red - high-level expression. The red dots </a:t>
            </a:r>
            <a:r>
              <a:rPr lang="en-US" sz="14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n MA-plots 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presents the potential miRNAs expressed upon </a:t>
            </a:r>
            <a:r>
              <a:rPr lang="en-US" sz="1400" i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. </a:t>
            </a:r>
            <a:r>
              <a:rPr lang="en-US" sz="1400" i="1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olani</a:t>
            </a:r>
            <a:r>
              <a:rPr lang="en-US" sz="14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infection.</a:t>
            </a:r>
            <a:endParaRPr lang="en-IN" sz="1400" dirty="0"/>
          </a:p>
        </p:txBody>
      </p:sp>
    </p:spTree>
    <p:extLst>
      <p:ext uri="{BB962C8B-B14F-4D97-AF65-F5344CB8AC3E}">
        <p14:creationId xmlns:p14="http://schemas.microsoft.com/office/powerpoint/2010/main" val="3331202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7</Words>
  <Application>Microsoft Office PowerPoint</Application>
  <PresentationFormat>A4 Paper (210x297 mm)</PresentationFormat>
  <Paragraphs>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HIRBAD GURIA</dc:creator>
  <cp:lastModifiedBy>ASHIRBAD GURIA</cp:lastModifiedBy>
  <cp:revision>3</cp:revision>
  <dcterms:created xsi:type="dcterms:W3CDTF">2022-02-04T02:23:30Z</dcterms:created>
  <dcterms:modified xsi:type="dcterms:W3CDTF">2022-02-04T03:02:47Z</dcterms:modified>
</cp:coreProperties>
</file>